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39" d="100"/>
          <a:sy n="39" d="100"/>
        </p:scale>
        <p:origin x="1839" y="3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390740740740741"/>
          <c:y val="4.2075820961720307E-2"/>
          <c:w val="0.66951443569553803"/>
          <c:h val="0.915848358076559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F3_454_Phylum level'!$B$3</c:f>
              <c:strCache>
                <c:ptCount val="1"/>
                <c:pt idx="0">
                  <c:v>Actinobacteria</c:v>
                </c:pt>
              </c:strCache>
            </c:strRef>
          </c:tx>
          <c:invertIfNegative val="0"/>
          <c:val>
            <c:numRef>
              <c:f>'F3_454_Phylum level'!$C$3:$N$3</c:f>
              <c:numCache>
                <c:formatCode>General</c:formatCode>
                <c:ptCount val="12"/>
                <c:pt idx="0">
                  <c:v>3.13545150502E-4</c:v>
                </c:pt>
                <c:pt idx="1">
                  <c:v>1.04854776135E-4</c:v>
                </c:pt>
                <c:pt idx="2">
                  <c:v>1.1675423234100001E-3</c:v>
                </c:pt>
                <c:pt idx="3">
                  <c:v>0.388986452584</c:v>
                </c:pt>
                <c:pt idx="4">
                  <c:v>0.41603276769999997</c:v>
                </c:pt>
                <c:pt idx="5">
                  <c:v>0.36153675327599999</c:v>
                </c:pt>
                <c:pt idx="6">
                  <c:v>8.1168831168800003E-4</c:v>
                </c:pt>
                <c:pt idx="7">
                  <c:v>1.4503263234199999E-4</c:v>
                </c:pt>
                <c:pt idx="8">
                  <c:v>1.9157088122600001E-4</c:v>
                </c:pt>
                <c:pt idx="9">
                  <c:v>0.124758390441</c:v>
                </c:pt>
                <c:pt idx="10">
                  <c:v>8.7931308634099994E-2</c:v>
                </c:pt>
                <c:pt idx="11">
                  <c:v>8.49497126437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CA-4C27-BF82-0902EEA18703}"/>
            </c:ext>
          </c:extLst>
        </c:ser>
        <c:ser>
          <c:idx val="1"/>
          <c:order val="1"/>
          <c:tx>
            <c:strRef>
              <c:f>'F3_454_Phylum level'!$B$4</c:f>
              <c:strCache>
                <c:ptCount val="1"/>
                <c:pt idx="0">
                  <c:v>Bacteroidetes</c:v>
                </c:pt>
              </c:strCache>
            </c:strRef>
          </c:tx>
          <c:invertIfNegative val="0"/>
          <c:val>
            <c:numRef>
              <c:f>'F3_454_Phylum level'!$C$4:$N$4</c:f>
              <c:numCache>
                <c:formatCode>General</c:formatCode>
                <c:ptCount val="12"/>
                <c:pt idx="0">
                  <c:v>0.61224916387999995</c:v>
                </c:pt>
                <c:pt idx="1">
                  <c:v>0.62608786830200003</c:v>
                </c:pt>
                <c:pt idx="2">
                  <c:v>0.58377116170499999</c:v>
                </c:pt>
                <c:pt idx="3">
                  <c:v>0.203211239338</c:v>
                </c:pt>
                <c:pt idx="4">
                  <c:v>0.193680514921</c:v>
                </c:pt>
                <c:pt idx="5">
                  <c:v>0.23073506551199999</c:v>
                </c:pt>
                <c:pt idx="6">
                  <c:v>0.53311688311700001</c:v>
                </c:pt>
                <c:pt idx="7">
                  <c:v>0.69108049311099995</c:v>
                </c:pt>
                <c:pt idx="8">
                  <c:v>0.70804597701100003</c:v>
                </c:pt>
                <c:pt idx="9">
                  <c:v>0.570725707257</c:v>
                </c:pt>
                <c:pt idx="10">
                  <c:v>0.54682779456200004</c:v>
                </c:pt>
                <c:pt idx="11">
                  <c:v>0.589978448275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4CA-4C27-BF82-0902EEA18703}"/>
            </c:ext>
          </c:extLst>
        </c:ser>
        <c:ser>
          <c:idx val="2"/>
          <c:order val="2"/>
          <c:tx>
            <c:strRef>
              <c:f>'F3_454_Phylum level'!$B$5</c:f>
              <c:strCache>
                <c:ptCount val="1"/>
                <c:pt idx="0">
                  <c:v>Firmicutes</c:v>
                </c:pt>
              </c:strCache>
            </c:strRef>
          </c:tx>
          <c:invertIfNegative val="0"/>
          <c:val>
            <c:numRef>
              <c:f>'F3_454_Phylum level'!$C$5:$N$5</c:f>
              <c:numCache>
                <c:formatCode>General</c:formatCode>
                <c:ptCount val="12"/>
                <c:pt idx="0">
                  <c:v>0.26870819398000001</c:v>
                </c:pt>
                <c:pt idx="1">
                  <c:v>0.27608262556399998</c:v>
                </c:pt>
                <c:pt idx="2">
                  <c:v>0.30779334500900002</c:v>
                </c:pt>
                <c:pt idx="3">
                  <c:v>0.24636226793800001</c:v>
                </c:pt>
                <c:pt idx="4">
                  <c:v>0.24361224887800001</c:v>
                </c:pt>
                <c:pt idx="5">
                  <c:v>0.26737730401999998</c:v>
                </c:pt>
                <c:pt idx="6">
                  <c:v>0.37516233766200002</c:v>
                </c:pt>
                <c:pt idx="7">
                  <c:v>0.26453952139199999</c:v>
                </c:pt>
                <c:pt idx="8">
                  <c:v>0.24482758620699999</c:v>
                </c:pt>
                <c:pt idx="9">
                  <c:v>0.236865225795</c:v>
                </c:pt>
                <c:pt idx="10">
                  <c:v>0.26554301160799998</c:v>
                </c:pt>
                <c:pt idx="11">
                  <c:v>0.244612068965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4CA-4C27-BF82-0902EEA18703}"/>
            </c:ext>
          </c:extLst>
        </c:ser>
        <c:ser>
          <c:idx val="3"/>
          <c:order val="3"/>
          <c:tx>
            <c:strRef>
              <c:f>'F3_454_Phylum level'!$B$6</c:f>
              <c:strCache>
                <c:ptCount val="1"/>
                <c:pt idx="0">
                  <c:v>Proteobacteria</c:v>
                </c:pt>
              </c:strCache>
            </c:strRef>
          </c:tx>
          <c:invertIfNegative val="0"/>
          <c:val>
            <c:numRef>
              <c:f>'F3_454_Phylum level'!$C$6:$N$6</c:f>
              <c:numCache>
                <c:formatCode>General</c:formatCode>
                <c:ptCount val="12"/>
                <c:pt idx="0">
                  <c:v>0.118206521739</c:v>
                </c:pt>
                <c:pt idx="1">
                  <c:v>9.6885813148800001E-2</c:v>
                </c:pt>
                <c:pt idx="2">
                  <c:v>0.106684179802</c:v>
                </c:pt>
                <c:pt idx="3">
                  <c:v>0.161314601104</c:v>
                </c:pt>
                <c:pt idx="4">
                  <c:v>0.14667446849999999</c:v>
                </c:pt>
                <c:pt idx="5">
                  <c:v>0.14012880302</c:v>
                </c:pt>
                <c:pt idx="6">
                  <c:v>8.4090909090900001E-2</c:v>
                </c:pt>
                <c:pt idx="7">
                  <c:v>3.7998549673699998E-2</c:v>
                </c:pt>
                <c:pt idx="8">
                  <c:v>4.1762452107300001E-2</c:v>
                </c:pt>
                <c:pt idx="9">
                  <c:v>6.7299244421000007E-2</c:v>
                </c:pt>
                <c:pt idx="10">
                  <c:v>9.9061854030800006E-2</c:v>
                </c:pt>
                <c:pt idx="11">
                  <c:v>8.02801724138000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4CA-4C27-BF82-0902EEA18703}"/>
            </c:ext>
          </c:extLst>
        </c:ser>
        <c:ser>
          <c:idx val="4"/>
          <c:order val="4"/>
          <c:tx>
            <c:strRef>
              <c:f>'F3_454_Phylum level'!$B$7</c:f>
              <c:strCache>
                <c:ptCount val="1"/>
                <c:pt idx="0">
                  <c:v>Others</c:v>
                </c:pt>
              </c:strCache>
            </c:strRef>
          </c:tx>
          <c:invertIfNegative val="0"/>
          <c:val>
            <c:numRef>
              <c:f>'F3_454_Phylum level'!$C$7:$N$7</c:f>
              <c:numCache>
                <c:formatCode>General</c:formatCode>
                <c:ptCount val="12"/>
                <c:pt idx="0">
                  <c:v>5.2257525049803633E-4</c:v>
                </c:pt>
                <c:pt idx="1">
                  <c:v>8.3883820906505147E-4</c:v>
                </c:pt>
                <c:pt idx="2">
                  <c:v>5.8377116059005196E-4</c:v>
                </c:pt>
                <c:pt idx="3">
                  <c:v>1.2543903600004125E-4</c:v>
                </c:pt>
                <c:pt idx="4">
                  <c:v>9.999778782798785E-13</c:v>
                </c:pt>
                <c:pt idx="5">
                  <c:v>2.2207417200015289E-4</c:v>
                </c:pt>
                <c:pt idx="6">
                  <c:v>6.8181818184119836E-3</c:v>
                </c:pt>
                <c:pt idx="7">
                  <c:v>6.2364031909580842E-3</c:v>
                </c:pt>
                <c:pt idx="8">
                  <c:v>5.1724137934739955E-3</c:v>
                </c:pt>
                <c:pt idx="9">
                  <c:v>3.5143208599996978E-4</c:v>
                </c:pt>
                <c:pt idx="10">
                  <c:v>6.3603116509991509E-4</c:v>
                </c:pt>
                <c:pt idx="11">
                  <c:v>1.795977005000226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4CA-4C27-BF82-0902EEA187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95655424"/>
        <c:axId val="95656960"/>
      </c:barChart>
      <c:catAx>
        <c:axId val="9565542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95656960"/>
        <c:crosses val="autoZero"/>
        <c:auto val="1"/>
        <c:lblAlgn val="ctr"/>
        <c:lblOffset val="100"/>
        <c:noMultiLvlLbl val="0"/>
      </c:catAx>
      <c:valAx>
        <c:axId val="9565696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 b="0"/>
                </a:pPr>
                <a:r>
                  <a:rPr lang="en-US" sz="1100" b="0" dirty="0"/>
                  <a:t>Relative abundance</a:t>
                </a:r>
              </a:p>
            </c:rich>
          </c:tx>
          <c:layout>
            <c:manualLayout>
              <c:xMode val="edge"/>
              <c:yMode val="edge"/>
              <c:x val="3.0954535855431863E-2"/>
              <c:y val="0.25397680610223033"/>
            </c:manualLayout>
          </c:layout>
          <c:overlay val="0"/>
        </c:title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de-DE"/>
          </a:p>
        </c:txPr>
        <c:crossAx val="95655424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79438682233686309"/>
          <c:y val="0.19120353220647834"/>
          <c:w val="0.18522790918612794"/>
          <c:h val="0.44881093690128065"/>
        </c:manualLayout>
      </c:layout>
      <c:overlay val="0"/>
      <c:txPr>
        <a:bodyPr/>
        <a:lstStyle/>
        <a:p>
          <a:pPr>
            <a:defRPr sz="1100"/>
          </a:pPr>
          <a:endParaRPr lang="de-DE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817183857073816"/>
          <c:y val="3.0249252162301885E-2"/>
          <c:w val="0.57388983671400551"/>
          <c:h val="0.9395014956753962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Chart in Microsoft PowerPoint]F3_454_family_MTZ&gt;1%'!$B$3</c:f>
              <c:strCache>
                <c:ptCount val="1"/>
                <c:pt idx="0">
                  <c:v>Actinomycetaceae</c:v>
                </c:pt>
              </c:strCache>
            </c:strRef>
          </c:tx>
          <c:invertIfNegative val="0"/>
          <c:val>
            <c:numRef>
              <c:f>'[Chart in Microsoft PowerPoint]F3_454_family_MTZ&gt;1%'!$C$3:$N$3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5.8377116170500005E-4</c:v>
                </c:pt>
                <c:pt idx="3">
                  <c:v>0.362267937782</c:v>
                </c:pt>
                <c:pt idx="4">
                  <c:v>0.38307002145500002</c:v>
                </c:pt>
                <c:pt idx="5">
                  <c:v>0.33644237175199998</c:v>
                </c:pt>
                <c:pt idx="6">
                  <c:v>4.8701298701300002E-4</c:v>
                </c:pt>
                <c:pt idx="7">
                  <c:v>1.4503263234199999E-4</c:v>
                </c:pt>
                <c:pt idx="8">
                  <c:v>0</c:v>
                </c:pt>
                <c:pt idx="9">
                  <c:v>0.124406958355</c:v>
                </c:pt>
                <c:pt idx="10">
                  <c:v>8.7295277468599997E-2</c:v>
                </c:pt>
                <c:pt idx="11">
                  <c:v>8.42313218390999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BE-49B1-A3CE-BD4DA40E6DEE}"/>
            </c:ext>
          </c:extLst>
        </c:ser>
        <c:ser>
          <c:idx val="1"/>
          <c:order val="1"/>
          <c:tx>
            <c:strRef>
              <c:f>'[Chart in Microsoft PowerPoint]F3_454_family_MTZ&gt;1%'!$B$4</c:f>
              <c:strCache>
                <c:ptCount val="1"/>
                <c:pt idx="0">
                  <c:v>Bifidobacteriaceae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</c:spPr>
          <c:invertIfNegative val="0"/>
          <c:val>
            <c:numRef>
              <c:f>'[Chart in Microsoft PowerPoint]F3_454_family_MTZ&gt;1%'!$C$4:$N$4</c:f>
              <c:numCache>
                <c:formatCode>General</c:formatCode>
                <c:ptCount val="12"/>
                <c:pt idx="0">
                  <c:v>1.04515050167E-4</c:v>
                </c:pt>
                <c:pt idx="1">
                  <c:v>0</c:v>
                </c:pt>
                <c:pt idx="2">
                  <c:v>5.8377116170500005E-4</c:v>
                </c:pt>
                <c:pt idx="3">
                  <c:v>2.4836929252400001E-2</c:v>
                </c:pt>
                <c:pt idx="4">
                  <c:v>2.82816461869E-2</c:v>
                </c:pt>
                <c:pt idx="5">
                  <c:v>2.2651565622900001E-2</c:v>
                </c:pt>
                <c:pt idx="6">
                  <c:v>1.6233766233800001E-4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3BE-49B1-A3CE-BD4DA40E6DEE}"/>
            </c:ext>
          </c:extLst>
        </c:ser>
        <c:ser>
          <c:idx val="2"/>
          <c:order val="2"/>
          <c:tx>
            <c:strRef>
              <c:f>'[Chart in Microsoft PowerPoint]F3_454_family_MTZ&gt;1%'!$B$5</c:f>
              <c:strCache>
                <c:ptCount val="1"/>
                <c:pt idx="0">
                  <c:v>Bacteroidaceae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val>
            <c:numRef>
              <c:f>'[Chart in Microsoft PowerPoint]F3_454_family_MTZ&gt;1%'!$C$5:$N$5</c:f>
              <c:numCache>
                <c:formatCode>General</c:formatCode>
                <c:ptCount val="12"/>
                <c:pt idx="0">
                  <c:v>0.59270484949799995</c:v>
                </c:pt>
                <c:pt idx="1">
                  <c:v>0.61256160218099998</c:v>
                </c:pt>
                <c:pt idx="2">
                  <c:v>0.57618213660200002</c:v>
                </c:pt>
                <c:pt idx="3">
                  <c:v>0.199698946312</c:v>
                </c:pt>
                <c:pt idx="4">
                  <c:v>0.19114491905600001</c:v>
                </c:pt>
                <c:pt idx="5">
                  <c:v>0.224294914501</c:v>
                </c:pt>
                <c:pt idx="6">
                  <c:v>0.52451298701299998</c:v>
                </c:pt>
                <c:pt idx="7">
                  <c:v>0.68208846990600003</c:v>
                </c:pt>
                <c:pt idx="8">
                  <c:v>0.69827586206900005</c:v>
                </c:pt>
                <c:pt idx="9">
                  <c:v>0.55051836232600004</c:v>
                </c:pt>
                <c:pt idx="10">
                  <c:v>0.52695182063900003</c:v>
                </c:pt>
                <c:pt idx="11">
                  <c:v>0.569324712643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3BE-49B1-A3CE-BD4DA40E6DEE}"/>
            </c:ext>
          </c:extLst>
        </c:ser>
        <c:ser>
          <c:idx val="3"/>
          <c:order val="3"/>
          <c:tx>
            <c:strRef>
              <c:f>'[Chart in Microsoft PowerPoint]F3_454_family_MTZ&gt;1%'!$B$6</c:f>
              <c:strCache>
                <c:ptCount val="1"/>
                <c:pt idx="0">
                  <c:v>Porphyromonadaceae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</c:spPr>
          <c:invertIfNegative val="0"/>
          <c:val>
            <c:numRef>
              <c:f>'[Chart in Microsoft PowerPoint]F3_454_family_MTZ&gt;1%'!$C$6:$N$6</c:f>
              <c:numCache>
                <c:formatCode>General</c:formatCode>
                <c:ptCount val="12"/>
                <c:pt idx="0">
                  <c:v>1.8708193979899999E-2</c:v>
                </c:pt>
                <c:pt idx="1">
                  <c:v>1.3211701793E-2</c:v>
                </c:pt>
                <c:pt idx="2">
                  <c:v>7.2971395213099997E-3</c:v>
                </c:pt>
                <c:pt idx="3">
                  <c:v>3.5122930255899998E-3</c:v>
                </c:pt>
                <c:pt idx="4">
                  <c:v>2.5355958650300002E-3</c:v>
                </c:pt>
                <c:pt idx="5">
                  <c:v>6.4401510104400003E-3</c:v>
                </c:pt>
                <c:pt idx="6">
                  <c:v>8.4415584415600004E-3</c:v>
                </c:pt>
                <c:pt idx="7">
                  <c:v>8.1218274111700007E-3</c:v>
                </c:pt>
                <c:pt idx="8">
                  <c:v>9.1954022988500004E-3</c:v>
                </c:pt>
                <c:pt idx="9">
                  <c:v>1.9855912844800001E-2</c:v>
                </c:pt>
                <c:pt idx="10">
                  <c:v>1.9716966131300001E-2</c:v>
                </c:pt>
                <c:pt idx="11">
                  <c:v>2.02945402299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3BE-49B1-A3CE-BD4DA40E6DEE}"/>
            </c:ext>
          </c:extLst>
        </c:ser>
        <c:ser>
          <c:idx val="4"/>
          <c:order val="4"/>
          <c:tx>
            <c:strRef>
              <c:f>'[Chart in Microsoft PowerPoint]F3_454_family_MTZ&gt;1%'!$B$7</c:f>
              <c:strCache>
                <c:ptCount val="1"/>
                <c:pt idx="0">
                  <c:v>uc Firmicutes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</c:spPr>
          <c:invertIfNegative val="0"/>
          <c:val>
            <c:numRef>
              <c:f>'[Chart in Microsoft PowerPoint]F3_454_family_MTZ&gt;1%'!$C$7:$N$7</c:f>
              <c:numCache>
                <c:formatCode>General</c:formatCode>
                <c:ptCount val="12"/>
                <c:pt idx="0">
                  <c:v>1.12876254181E-2</c:v>
                </c:pt>
                <c:pt idx="1">
                  <c:v>7.9689629862600003E-3</c:v>
                </c:pt>
                <c:pt idx="2">
                  <c:v>1.5323992994699999E-2</c:v>
                </c:pt>
                <c:pt idx="3">
                  <c:v>7.0998494731599998E-2</c:v>
                </c:pt>
                <c:pt idx="4">
                  <c:v>5.9684025746100003E-2</c:v>
                </c:pt>
                <c:pt idx="5">
                  <c:v>8.77192982456E-2</c:v>
                </c:pt>
                <c:pt idx="6">
                  <c:v>6.4285714285699999E-2</c:v>
                </c:pt>
                <c:pt idx="7">
                  <c:v>3.2342277012299997E-2</c:v>
                </c:pt>
                <c:pt idx="8">
                  <c:v>1.81992337165E-2</c:v>
                </c:pt>
                <c:pt idx="9">
                  <c:v>1.5814443858700001E-2</c:v>
                </c:pt>
                <c:pt idx="10">
                  <c:v>1.8444903800299998E-2</c:v>
                </c:pt>
                <c:pt idx="11">
                  <c:v>1.688218390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3BE-49B1-A3CE-BD4DA40E6DEE}"/>
            </c:ext>
          </c:extLst>
        </c:ser>
        <c:ser>
          <c:idx val="5"/>
          <c:order val="5"/>
          <c:tx>
            <c:strRef>
              <c:f>'[Chart in Microsoft PowerPoint]F3_454_family_MTZ&gt;1%'!$B$8</c:f>
              <c:strCache>
                <c:ptCount val="1"/>
                <c:pt idx="0">
                  <c:v>uc Lactobacillales</c:v>
                </c:pt>
              </c:strCache>
            </c:strRef>
          </c:tx>
          <c:spPr>
            <a:solidFill>
              <a:schemeClr val="accent3">
                <a:lumMod val="40000"/>
                <a:lumOff val="60000"/>
              </a:schemeClr>
            </a:solidFill>
          </c:spPr>
          <c:invertIfNegative val="0"/>
          <c:val>
            <c:numRef>
              <c:f>'[Chart in Microsoft PowerPoint]F3_454_family_MTZ&gt;1%'!$C$8:$N$8</c:f>
              <c:numCache>
                <c:formatCode>General</c:formatCode>
                <c:ptCount val="12"/>
                <c:pt idx="0">
                  <c:v>7.62959866221E-3</c:v>
                </c:pt>
                <c:pt idx="1">
                  <c:v>7.23497955332E-3</c:v>
                </c:pt>
                <c:pt idx="2">
                  <c:v>1.12375948628E-2</c:v>
                </c:pt>
                <c:pt idx="3">
                  <c:v>5.9332664325100003E-2</c:v>
                </c:pt>
                <c:pt idx="4">
                  <c:v>7.4312463428899994E-2</c:v>
                </c:pt>
                <c:pt idx="5">
                  <c:v>4.1527870308699998E-2</c:v>
                </c:pt>
                <c:pt idx="6">
                  <c:v>2.2077922077899999E-2</c:v>
                </c:pt>
                <c:pt idx="7">
                  <c:v>1.0732414793299999E-2</c:v>
                </c:pt>
                <c:pt idx="8">
                  <c:v>2.0881226053599999E-2</c:v>
                </c:pt>
                <c:pt idx="9">
                  <c:v>1.93287647162E-2</c:v>
                </c:pt>
                <c:pt idx="10">
                  <c:v>2.1943075210699999E-2</c:v>
                </c:pt>
                <c:pt idx="11">
                  <c:v>2.17313218390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3BE-49B1-A3CE-BD4DA40E6DEE}"/>
            </c:ext>
          </c:extLst>
        </c:ser>
        <c:ser>
          <c:idx val="6"/>
          <c:order val="6"/>
          <c:tx>
            <c:strRef>
              <c:f>'[Chart in Microsoft PowerPoint]F3_454_family_MTZ&gt;1%'!$B$9</c:f>
              <c:strCache>
                <c:ptCount val="1"/>
                <c:pt idx="0">
                  <c:v>Enterococcaceae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</c:spPr>
          <c:invertIfNegative val="0"/>
          <c:val>
            <c:numRef>
              <c:f>'[Chart in Microsoft PowerPoint]F3_454_family_MTZ&gt;1%'!$C$9:$N$9</c:f>
              <c:numCache>
                <c:formatCode>General</c:formatCode>
                <c:ptCount val="12"/>
                <c:pt idx="0">
                  <c:v>2.4038461538499999E-3</c:v>
                </c:pt>
                <c:pt idx="1">
                  <c:v>2.0970955226999998E-3</c:v>
                </c:pt>
                <c:pt idx="2">
                  <c:v>3.0647985989499999E-3</c:v>
                </c:pt>
                <c:pt idx="3">
                  <c:v>6.6482689412900003E-2</c:v>
                </c:pt>
                <c:pt idx="4">
                  <c:v>6.06592549249E-2</c:v>
                </c:pt>
                <c:pt idx="5">
                  <c:v>7.6171441261400005E-2</c:v>
                </c:pt>
                <c:pt idx="6">
                  <c:v>1.1363636363600001E-2</c:v>
                </c:pt>
                <c:pt idx="7">
                  <c:v>6.8165337200900003E-3</c:v>
                </c:pt>
                <c:pt idx="8">
                  <c:v>5.7471264367800002E-3</c:v>
                </c:pt>
                <c:pt idx="9">
                  <c:v>8.9615181866099999E-3</c:v>
                </c:pt>
                <c:pt idx="10">
                  <c:v>1.0971537605299999E-2</c:v>
                </c:pt>
                <c:pt idx="11">
                  <c:v>1.4727011494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3BE-49B1-A3CE-BD4DA40E6DEE}"/>
            </c:ext>
          </c:extLst>
        </c:ser>
        <c:ser>
          <c:idx val="7"/>
          <c:order val="7"/>
          <c:tx>
            <c:strRef>
              <c:f>'[Chart in Microsoft PowerPoint]F3_454_family_MTZ&gt;1%'!$B$10</c:f>
              <c:strCache>
                <c:ptCount val="1"/>
                <c:pt idx="0">
                  <c:v>Lactobacillaceae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val>
            <c:numRef>
              <c:f>'[Chart in Microsoft PowerPoint]F3_454_family_MTZ&gt;1%'!$C$10:$N$10</c:f>
              <c:numCache>
                <c:formatCode>General</c:formatCode>
                <c:ptCount val="12"/>
                <c:pt idx="0">
                  <c:v>4.07608695652E-3</c:v>
                </c:pt>
                <c:pt idx="1">
                  <c:v>1.4679668658899999E-3</c:v>
                </c:pt>
                <c:pt idx="2">
                  <c:v>3.5026269702300001E-3</c:v>
                </c:pt>
                <c:pt idx="3">
                  <c:v>1.5178123432E-2</c:v>
                </c:pt>
                <c:pt idx="4">
                  <c:v>1.17027501463E-2</c:v>
                </c:pt>
                <c:pt idx="5">
                  <c:v>1.3768598712000001E-2</c:v>
                </c:pt>
                <c:pt idx="6">
                  <c:v>8.9285714285700004E-3</c:v>
                </c:pt>
                <c:pt idx="7">
                  <c:v>4.4960116026100004E-3</c:v>
                </c:pt>
                <c:pt idx="8">
                  <c:v>2.2988505747099999E-3</c:v>
                </c:pt>
                <c:pt idx="9">
                  <c:v>3.16288877174E-3</c:v>
                </c:pt>
                <c:pt idx="10">
                  <c:v>1.59007791382E-3</c:v>
                </c:pt>
                <c:pt idx="11">
                  <c:v>3.05316091954000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3BE-49B1-A3CE-BD4DA40E6DEE}"/>
            </c:ext>
          </c:extLst>
        </c:ser>
        <c:ser>
          <c:idx val="8"/>
          <c:order val="8"/>
          <c:tx>
            <c:strRef>
              <c:f>'[Chart in Microsoft PowerPoint]F3_454_family_MTZ&gt;1%'!$B$11</c:f>
              <c:strCache>
                <c:ptCount val="1"/>
                <c:pt idx="0">
                  <c:v>Streptococcaceae</c:v>
                </c:pt>
              </c:strCache>
            </c:strRef>
          </c:tx>
          <c:invertIfNegative val="0"/>
          <c:val>
            <c:numRef>
              <c:f>'[Chart in Microsoft PowerPoint]F3_454_family_MTZ&gt;1%'!$C$11:$N$11</c:f>
              <c:numCache>
                <c:formatCode>General</c:formatCode>
                <c:ptCount val="12"/>
                <c:pt idx="0">
                  <c:v>6.1663879598700001E-3</c:v>
                </c:pt>
                <c:pt idx="1">
                  <c:v>5.8718674635599996E-3</c:v>
                </c:pt>
                <c:pt idx="2">
                  <c:v>1.10916520724E-2</c:v>
                </c:pt>
                <c:pt idx="3">
                  <c:v>1.8941294530899998E-2</c:v>
                </c:pt>
                <c:pt idx="4">
                  <c:v>1.7944216890999998E-2</c:v>
                </c:pt>
                <c:pt idx="5">
                  <c:v>1.6211414612499999E-2</c:v>
                </c:pt>
                <c:pt idx="6">
                  <c:v>3.1493506493500002E-2</c:v>
                </c:pt>
                <c:pt idx="7">
                  <c:v>2.1319796954299999E-2</c:v>
                </c:pt>
                <c:pt idx="8">
                  <c:v>1.26436781609E-2</c:v>
                </c:pt>
                <c:pt idx="9">
                  <c:v>2.8114566859999999E-2</c:v>
                </c:pt>
                <c:pt idx="10">
                  <c:v>2.8462394657300001E-2</c:v>
                </c:pt>
                <c:pt idx="11">
                  <c:v>2.0653735632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3BE-49B1-A3CE-BD4DA40E6DEE}"/>
            </c:ext>
          </c:extLst>
        </c:ser>
        <c:ser>
          <c:idx val="9"/>
          <c:order val="9"/>
          <c:tx>
            <c:strRef>
              <c:f>'[Chart in Microsoft PowerPoint]F3_454_family_MTZ&gt;1%'!$B$12</c:f>
              <c:strCache>
                <c:ptCount val="1"/>
                <c:pt idx="0">
                  <c:v>Clostridiales Family XI Incertae Sedis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</c:spPr>
          <c:invertIfNegative val="0"/>
          <c:val>
            <c:numRef>
              <c:f>'[Chart in Microsoft PowerPoint]F3_454_family_MTZ&gt;1%'!$C$12:$N$12</c:f>
              <c:numCache>
                <c:formatCode>General</c:formatCode>
                <c:ptCount val="12"/>
                <c:pt idx="0">
                  <c:v>3.4698996655499997E-2</c:v>
                </c:pt>
                <c:pt idx="1">
                  <c:v>3.2924399706400001E-2</c:v>
                </c:pt>
                <c:pt idx="2">
                  <c:v>3.22533566841999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8928571428600002E-2</c:v>
                </c:pt>
                <c:pt idx="7">
                  <c:v>3.5823060188499997E-2</c:v>
                </c:pt>
                <c:pt idx="8">
                  <c:v>3.8314176245199998E-2</c:v>
                </c:pt>
                <c:pt idx="9">
                  <c:v>3.8833245475300003E-2</c:v>
                </c:pt>
                <c:pt idx="10">
                  <c:v>4.19780569248E-2</c:v>
                </c:pt>
                <c:pt idx="11">
                  <c:v>3.59195402299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13BE-49B1-A3CE-BD4DA40E6DEE}"/>
            </c:ext>
          </c:extLst>
        </c:ser>
        <c:ser>
          <c:idx val="10"/>
          <c:order val="10"/>
          <c:tx>
            <c:strRef>
              <c:f>'[Chart in Microsoft PowerPoint]F3_454_family_MTZ&gt;1%'!$B$13</c:f>
              <c:strCache>
                <c:ptCount val="1"/>
                <c:pt idx="0">
                  <c:v>Lachnospiraceae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val>
            <c:numRef>
              <c:f>'[Chart in Microsoft PowerPoint]F3_454_family_MTZ&gt;1%'!$C$13:$N$13</c:f>
              <c:numCache>
                <c:formatCode>General</c:formatCode>
                <c:ptCount val="12"/>
                <c:pt idx="0">
                  <c:v>8.9464882943099996E-2</c:v>
                </c:pt>
                <c:pt idx="1">
                  <c:v>9.5208136730599996E-2</c:v>
                </c:pt>
                <c:pt idx="2">
                  <c:v>0.119527145359</c:v>
                </c:pt>
                <c:pt idx="3">
                  <c:v>4.3903662819899996E-3</c:v>
                </c:pt>
                <c:pt idx="4">
                  <c:v>4.2910083869700001E-3</c:v>
                </c:pt>
                <c:pt idx="5">
                  <c:v>1.28803020209E-2</c:v>
                </c:pt>
                <c:pt idx="6">
                  <c:v>8.3116883116900006E-2</c:v>
                </c:pt>
                <c:pt idx="7">
                  <c:v>6.4394488759999993E-2</c:v>
                </c:pt>
                <c:pt idx="8">
                  <c:v>6.3026819923399993E-2</c:v>
                </c:pt>
                <c:pt idx="9">
                  <c:v>9.6116675452499994E-2</c:v>
                </c:pt>
                <c:pt idx="10">
                  <c:v>0.108284305931</c:v>
                </c:pt>
                <c:pt idx="11">
                  <c:v>9.84195402299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3BE-49B1-A3CE-BD4DA40E6DEE}"/>
            </c:ext>
          </c:extLst>
        </c:ser>
        <c:ser>
          <c:idx val="11"/>
          <c:order val="11"/>
          <c:tx>
            <c:strRef>
              <c:f>'[Chart in Microsoft PowerPoint]F3_454_family_MTZ&gt;1%'!$B$14</c:f>
              <c:strCache>
                <c:ptCount val="1"/>
                <c:pt idx="0">
                  <c:v>Peptostreptococcaceae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val>
            <c:numRef>
              <c:f>'[Chart in Microsoft PowerPoint]F3_454_family_MTZ&gt;1%'!$C$14:$N$14</c:f>
              <c:numCache>
                <c:formatCode>General</c:formatCode>
                <c:ptCount val="12"/>
                <c:pt idx="0">
                  <c:v>2.4247491638799998E-2</c:v>
                </c:pt>
                <c:pt idx="1">
                  <c:v>1.2477718360100001E-2</c:v>
                </c:pt>
                <c:pt idx="2">
                  <c:v>2.3350846468200001E-2</c:v>
                </c:pt>
                <c:pt idx="3">
                  <c:v>0</c:v>
                </c:pt>
                <c:pt idx="4">
                  <c:v>0</c:v>
                </c:pt>
                <c:pt idx="5">
                  <c:v>4.4414834554699998E-4</c:v>
                </c:pt>
                <c:pt idx="6">
                  <c:v>3.6201298701299997E-2</c:v>
                </c:pt>
                <c:pt idx="7">
                  <c:v>2.9586656997800002E-2</c:v>
                </c:pt>
                <c:pt idx="8">
                  <c:v>2.89272030651E-2</c:v>
                </c:pt>
                <c:pt idx="9">
                  <c:v>1.1772974872599999E-2</c:v>
                </c:pt>
                <c:pt idx="10">
                  <c:v>1.39926856416E-2</c:v>
                </c:pt>
                <c:pt idx="11">
                  <c:v>1.32902298851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3BE-49B1-A3CE-BD4DA40E6DEE}"/>
            </c:ext>
          </c:extLst>
        </c:ser>
        <c:ser>
          <c:idx val="12"/>
          <c:order val="12"/>
          <c:tx>
            <c:strRef>
              <c:f>'[Chart in Microsoft PowerPoint]F3_454_family_MTZ&gt;1%'!$B$15</c:f>
              <c:strCache>
                <c:ptCount val="1"/>
                <c:pt idx="0">
                  <c:v>Ruminococcaceae</c:v>
                </c:pt>
              </c:strCache>
            </c:strRef>
          </c:tx>
          <c:spPr>
            <a:solidFill>
              <a:srgbClr val="00CC99"/>
            </a:solidFill>
          </c:spPr>
          <c:invertIfNegative val="0"/>
          <c:val>
            <c:numRef>
              <c:f>'[Chart in Microsoft PowerPoint]F3_454_family_MTZ&gt;1%'!$C$15:$N$15</c:f>
              <c:numCache>
                <c:formatCode>General</c:formatCode>
                <c:ptCount val="12"/>
                <c:pt idx="0">
                  <c:v>8.2775919732400005E-2</c:v>
                </c:pt>
                <c:pt idx="1">
                  <c:v>0.104120792702</c:v>
                </c:pt>
                <c:pt idx="2">
                  <c:v>8.4500875656700003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3409090909100003E-2</c:v>
                </c:pt>
                <c:pt idx="7">
                  <c:v>5.4242204496E-2</c:v>
                </c:pt>
                <c:pt idx="8">
                  <c:v>4.9616858237499999E-2</c:v>
                </c:pt>
                <c:pt idx="9">
                  <c:v>5.6229133719899998E-3</c:v>
                </c:pt>
                <c:pt idx="10">
                  <c:v>1.33566544761E-2</c:v>
                </c:pt>
                <c:pt idx="11">
                  <c:v>1.04166666667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3BE-49B1-A3CE-BD4DA40E6DEE}"/>
            </c:ext>
          </c:extLst>
        </c:ser>
        <c:ser>
          <c:idx val="13"/>
          <c:order val="13"/>
          <c:tx>
            <c:strRef>
              <c:f>'[Chart in Microsoft PowerPoint]F3_454_family_MTZ&gt;1%'!$B$16</c:f>
              <c:strCache>
                <c:ptCount val="1"/>
                <c:pt idx="0">
                  <c:v>Veillonellaceae</c:v>
                </c:pt>
              </c:strCache>
            </c:strRef>
          </c:tx>
          <c:spPr>
            <a:solidFill>
              <a:srgbClr val="009999"/>
            </a:solidFill>
          </c:spPr>
          <c:invertIfNegative val="0"/>
          <c:val>
            <c:numRef>
              <c:f>'[Chart in Microsoft PowerPoint]F3_454_family_MTZ&gt;1%'!$C$16:$N$16</c:f>
              <c:numCache>
                <c:formatCode>General</c:formatCode>
                <c:ptCount val="12"/>
                <c:pt idx="0">
                  <c:v>8.3612040133800004E-4</c:v>
                </c:pt>
                <c:pt idx="1">
                  <c:v>1.57282164203E-3</c:v>
                </c:pt>
                <c:pt idx="2">
                  <c:v>8.7565674255699999E-4</c:v>
                </c:pt>
                <c:pt idx="3">
                  <c:v>8.6552935273500001E-3</c:v>
                </c:pt>
                <c:pt idx="4">
                  <c:v>1.1117612638999999E-2</c:v>
                </c:pt>
                <c:pt idx="5">
                  <c:v>1.33244503664E-2</c:v>
                </c:pt>
                <c:pt idx="6">
                  <c:v>8.1168831168800003E-4</c:v>
                </c:pt>
                <c:pt idx="7">
                  <c:v>1.0152284263999999E-3</c:v>
                </c:pt>
                <c:pt idx="8">
                  <c:v>7.6628352490400002E-4</c:v>
                </c:pt>
                <c:pt idx="9">
                  <c:v>2.2843085573700001E-3</c:v>
                </c:pt>
                <c:pt idx="10">
                  <c:v>2.7031324534899999E-3</c:v>
                </c:pt>
                <c:pt idx="11">
                  <c:v>4.4899425287399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13BE-49B1-A3CE-BD4DA40E6DEE}"/>
            </c:ext>
          </c:extLst>
        </c:ser>
        <c:ser>
          <c:idx val="14"/>
          <c:order val="14"/>
          <c:tx>
            <c:strRef>
              <c:f>'[Chart in Microsoft PowerPoint]F3_454_family_MTZ&gt;1%'!$B$17</c:f>
              <c:strCache>
                <c:ptCount val="1"/>
                <c:pt idx="0">
                  <c:v>Enterobacteriaceae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val>
            <c:numRef>
              <c:f>'[Chart in Microsoft PowerPoint]F3_454_family_MTZ&gt;1%'!$C$17:$N$17</c:f>
              <c:numCache>
                <c:formatCode>General</c:formatCode>
                <c:ptCount val="12"/>
                <c:pt idx="0">
                  <c:v>0.11810200668900001</c:v>
                </c:pt>
                <c:pt idx="1">
                  <c:v>9.5627555835199995E-2</c:v>
                </c:pt>
                <c:pt idx="2">
                  <c:v>0.10639229422099999</c:v>
                </c:pt>
                <c:pt idx="3">
                  <c:v>0.161314601104</c:v>
                </c:pt>
                <c:pt idx="4">
                  <c:v>0.14667446849999999</c:v>
                </c:pt>
                <c:pt idx="5">
                  <c:v>0.14012880302</c:v>
                </c:pt>
                <c:pt idx="6">
                  <c:v>8.3766233766200002E-2</c:v>
                </c:pt>
                <c:pt idx="7">
                  <c:v>3.7418419144299997E-2</c:v>
                </c:pt>
                <c:pt idx="8">
                  <c:v>4.0996168582400003E-2</c:v>
                </c:pt>
                <c:pt idx="9">
                  <c:v>6.5366367949399998E-2</c:v>
                </c:pt>
                <c:pt idx="10">
                  <c:v>9.7312768325599999E-2</c:v>
                </c:pt>
                <c:pt idx="11">
                  <c:v>7.92025862069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13BE-49B1-A3CE-BD4DA40E6DEE}"/>
            </c:ext>
          </c:extLst>
        </c:ser>
        <c:ser>
          <c:idx val="15"/>
          <c:order val="15"/>
          <c:tx>
            <c:strRef>
              <c:f>'[Chart in Microsoft PowerPoint]F3_454_family_MTZ&gt;1%'!$B$18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val>
            <c:numRef>
              <c:f>'[Chart in Microsoft PowerPoint]F3_454_family_MTZ&gt;1%'!$C$18:$N$18</c:f>
              <c:numCache>
                <c:formatCode>General</c:formatCode>
                <c:ptCount val="12"/>
                <c:pt idx="0">
                  <c:v>6.7934782612451006E-3</c:v>
                </c:pt>
                <c:pt idx="1">
                  <c:v>7.6543986579398204E-3</c:v>
                </c:pt>
                <c:pt idx="2">
                  <c:v>4.2323409225430986E-3</c:v>
                </c:pt>
                <c:pt idx="3">
                  <c:v>4.390366282170155E-3</c:v>
                </c:pt>
                <c:pt idx="4">
                  <c:v>8.5820167739000253E-3</c:v>
                </c:pt>
                <c:pt idx="5">
                  <c:v>7.9946702206132869E-3</c:v>
                </c:pt>
                <c:pt idx="6">
                  <c:v>1.2012987013031107E-2</c:v>
                </c:pt>
                <c:pt idx="7">
                  <c:v>1.1457577954887999E-2</c:v>
                </c:pt>
                <c:pt idx="8">
                  <c:v>1.1111111111156147E-2</c:v>
                </c:pt>
                <c:pt idx="9">
                  <c:v>9.8400984017898985E-3</c:v>
                </c:pt>
                <c:pt idx="10">
                  <c:v>6.9963428210898515E-3</c:v>
                </c:pt>
                <c:pt idx="11">
                  <c:v>7.36350574662014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13BE-49B1-A3CE-BD4DA40E6D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97188864"/>
        <c:axId val="106177280"/>
      </c:barChart>
      <c:catAx>
        <c:axId val="971888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106177280"/>
        <c:crosses val="autoZero"/>
        <c:auto val="1"/>
        <c:lblAlgn val="ctr"/>
        <c:lblOffset val="100"/>
        <c:noMultiLvlLbl val="0"/>
      </c:catAx>
      <c:valAx>
        <c:axId val="10617728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 b="0"/>
                </a:pPr>
                <a:r>
                  <a:rPr lang="en-US" sz="1100" b="0"/>
                  <a:t>Relative abundance</a:t>
                </a:r>
              </a:p>
            </c:rich>
          </c:tx>
          <c:layout>
            <c:manualLayout>
              <c:xMode val="edge"/>
              <c:yMode val="edge"/>
              <c:x val="2.5495034788153854E-2"/>
              <c:y val="0.31792884914953695"/>
            </c:manualLayout>
          </c:layout>
          <c:overlay val="0"/>
        </c:title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de-DE"/>
          </a:p>
        </c:txPr>
        <c:crossAx val="97188864"/>
        <c:crosses val="autoZero"/>
        <c:crossBetween val="between"/>
        <c:majorUnit val="0.2"/>
      </c:valAx>
    </c:plotArea>
    <c:legend>
      <c:legendPos val="r"/>
      <c:legendEntry>
        <c:idx val="1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2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3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4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5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7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8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9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12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13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14"/>
        <c:txPr>
          <a:bodyPr/>
          <a:lstStyle/>
          <a:p>
            <a:pPr>
              <a:defRPr sz="1100" i="1"/>
            </a:pPr>
            <a:endParaRPr lang="de-DE"/>
          </a:p>
        </c:txPr>
      </c:legendEntry>
      <c:legendEntry>
        <c:idx val="15"/>
        <c:txPr>
          <a:bodyPr/>
          <a:lstStyle/>
          <a:p>
            <a:pPr>
              <a:defRPr sz="1100" i="1"/>
            </a:pPr>
            <a:endParaRPr lang="de-DE"/>
          </a:p>
        </c:txPr>
      </c:legendEntry>
      <c:layout>
        <c:manualLayout>
          <c:xMode val="edge"/>
          <c:yMode val="edge"/>
          <c:x val="0.68658589046417406"/>
          <c:y val="1.7579876033225639E-2"/>
          <c:w val="0.22149159593384107"/>
          <c:h val="0.94713592544284431"/>
        </c:manualLayout>
      </c:layout>
      <c:overlay val="0"/>
      <c:txPr>
        <a:bodyPr/>
        <a:lstStyle/>
        <a:p>
          <a:pPr>
            <a:defRPr sz="1100"/>
          </a:pPr>
          <a:endParaRPr lang="de-DE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289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576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49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72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929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092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584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847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275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7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515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A9FBA-573C-412F-BC4D-11815EDC85A7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4E442-799D-4738-8C1F-9786FAC37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52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224604"/>
            <a:ext cx="5181600" cy="8641259"/>
            <a:chOff x="152400" y="76200"/>
            <a:chExt cx="5181600" cy="8789664"/>
          </a:xfrm>
        </p:grpSpPr>
        <p:grpSp>
          <p:nvGrpSpPr>
            <p:cNvPr id="25" name="Group 24"/>
            <p:cNvGrpSpPr/>
            <p:nvPr/>
          </p:nvGrpSpPr>
          <p:grpSpPr>
            <a:xfrm>
              <a:off x="1930012" y="87624"/>
              <a:ext cx="2227015" cy="8778240"/>
              <a:chOff x="1828800" y="175253"/>
              <a:chExt cx="2362200" cy="7895695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1828800" y="381000"/>
                <a:ext cx="0" cy="7648954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3002673" y="175253"/>
                <a:ext cx="0" cy="7895695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4191000" y="402608"/>
                <a:ext cx="0" cy="7648955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>
              <a:off x="152400" y="157773"/>
              <a:ext cx="304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2400" y="3878189"/>
              <a:ext cx="304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" name="TextBox 2"/>
            <p:cNvSpPr txBox="1"/>
            <p:nvPr/>
          </p:nvSpPr>
          <p:spPr>
            <a:xfrm>
              <a:off x="816505" y="344678"/>
              <a:ext cx="1110043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788638" y="322997"/>
              <a:ext cx="44805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"/>
            <p:cNvSpPr txBox="1"/>
            <p:nvPr/>
          </p:nvSpPr>
          <p:spPr>
            <a:xfrm>
              <a:off x="762000" y="76200"/>
              <a:ext cx="2286000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 last days of period E (MTZ)</a:t>
              </a:r>
            </a:p>
          </p:txBody>
        </p:sp>
        <p:sp>
          <p:nvSpPr>
            <p:cNvPr id="29" name="TextBox 2"/>
            <p:cNvSpPr txBox="1"/>
            <p:nvPr/>
          </p:nvSpPr>
          <p:spPr>
            <a:xfrm>
              <a:off x="3048000" y="80265"/>
              <a:ext cx="2286000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 last days of period F (REC)</a:t>
              </a:r>
            </a:p>
          </p:txBody>
        </p:sp>
        <p:sp>
          <p:nvSpPr>
            <p:cNvPr id="30" name="TextBox 2"/>
            <p:cNvSpPr txBox="1"/>
            <p:nvPr/>
          </p:nvSpPr>
          <p:spPr>
            <a:xfrm>
              <a:off x="1926548" y="344678"/>
              <a:ext cx="1110043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4</a:t>
              </a:r>
            </a:p>
          </p:txBody>
        </p:sp>
        <p:sp>
          <p:nvSpPr>
            <p:cNvPr id="31" name="TextBox 2"/>
            <p:cNvSpPr txBox="1"/>
            <p:nvPr/>
          </p:nvSpPr>
          <p:spPr>
            <a:xfrm>
              <a:off x="3043520" y="336789"/>
              <a:ext cx="1110043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</a:t>
              </a:r>
            </a:p>
          </p:txBody>
        </p:sp>
        <p:sp>
          <p:nvSpPr>
            <p:cNvPr id="32" name="TextBox 2"/>
            <p:cNvSpPr txBox="1"/>
            <p:nvPr/>
          </p:nvSpPr>
          <p:spPr>
            <a:xfrm>
              <a:off x="4153563" y="336789"/>
              <a:ext cx="1110043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4</a:t>
              </a:r>
            </a:p>
          </p:txBody>
        </p:sp>
      </p:grp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0042617"/>
              </p:ext>
            </p:extLst>
          </p:nvPr>
        </p:nvGraphicFramePr>
        <p:xfrm>
          <a:off x="-152400" y="685800"/>
          <a:ext cx="6629400" cy="3171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2803734"/>
              </p:ext>
            </p:extLst>
          </p:nvPr>
        </p:nvGraphicFramePr>
        <p:xfrm>
          <a:off x="-165847" y="4298576"/>
          <a:ext cx="7720013" cy="4679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49930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ISG D-AgrL - ETH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hlbaum  Sophie</dc:creator>
  <cp:lastModifiedBy>Sophie Fehlbaum</cp:lastModifiedBy>
  <cp:revision>10</cp:revision>
  <dcterms:created xsi:type="dcterms:W3CDTF">2015-03-28T16:43:34Z</dcterms:created>
  <dcterms:modified xsi:type="dcterms:W3CDTF">2016-10-21T08:03:42Z</dcterms:modified>
</cp:coreProperties>
</file>